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9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61E9C97D-8F7C-427D-8654-4DD48FC94ADF}" v="2" dt="2023-07-30T01:16:43.187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>
      <p:cViewPr varScale="1">
        <p:scale>
          <a:sx n="42" d="100"/>
          <a:sy n="42" d="100"/>
        </p:scale>
        <p:origin x="2280" y="4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microsoft.com/office/2015/10/relationships/revisionInfo" Target="revisionInfo.xml"/><Relationship Id="rId3" Type="http://schemas.openxmlformats.org/officeDocument/2006/relationships/presProps" Target="presProps.xml"/><Relationship Id="rId7" Type="http://schemas.microsoft.com/office/2016/11/relationships/changesInfo" Target="changesInfos/changesInfo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PRIYA RANI" userId="168e54ad-9b2c-4b18-be83-178c2e373f06" providerId="ADAL" clId="{61E9C97D-8F7C-427D-8654-4DD48FC94ADF}"/>
    <pc:docChg chg="addSld delSld modSld">
      <pc:chgData name="PRIYA RANI" userId="168e54ad-9b2c-4b18-be83-178c2e373f06" providerId="ADAL" clId="{61E9C97D-8F7C-427D-8654-4DD48FC94ADF}" dt="2023-07-30T01:16:45.367" v="2" actId="47"/>
      <pc:docMkLst>
        <pc:docMk/>
      </pc:docMkLst>
      <pc:sldChg chg="new del">
        <pc:chgData name="PRIYA RANI" userId="168e54ad-9b2c-4b18-be83-178c2e373f06" providerId="ADAL" clId="{61E9C97D-8F7C-427D-8654-4DD48FC94ADF}" dt="2023-07-30T01:16:45.367" v="2" actId="47"/>
        <pc:sldMkLst>
          <pc:docMk/>
          <pc:sldMk cId="866988651" sldId="256"/>
        </pc:sldMkLst>
      </pc:sldChg>
      <pc:sldChg chg="add">
        <pc:chgData name="PRIYA RANI" userId="168e54ad-9b2c-4b18-be83-178c2e373f06" providerId="ADAL" clId="{61E9C97D-8F7C-427D-8654-4DD48FC94ADF}" dt="2023-07-30T01:16:43.187" v="1"/>
        <pc:sldMkLst>
          <pc:docMk/>
          <pc:sldMk cId="3635226783" sldId="259"/>
        </pc:sldMkLst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CE4F64-7B8F-42E4-8E79-3F55635B8874}" type="datetimeFigureOut">
              <a:rPr lang="en-IN" smtClean="0"/>
              <a:t>30-07-2023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B54710-83D2-4A79-80FC-3F77082AE50F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43737809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CE4F64-7B8F-42E4-8E79-3F55635B8874}" type="datetimeFigureOut">
              <a:rPr lang="en-IN" smtClean="0"/>
              <a:t>30-07-2023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B54710-83D2-4A79-80FC-3F77082AE50F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90981070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CE4F64-7B8F-42E4-8E79-3F55635B8874}" type="datetimeFigureOut">
              <a:rPr lang="en-IN" smtClean="0"/>
              <a:t>30-07-2023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B54710-83D2-4A79-80FC-3F77082AE50F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91036455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CE4F64-7B8F-42E4-8E79-3F55635B8874}" type="datetimeFigureOut">
              <a:rPr lang="en-IN" smtClean="0"/>
              <a:t>30-07-2023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B54710-83D2-4A79-80FC-3F77082AE50F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3211307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CE4F64-7B8F-42E4-8E79-3F55635B8874}" type="datetimeFigureOut">
              <a:rPr lang="en-IN" smtClean="0"/>
              <a:t>30-07-2023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B54710-83D2-4A79-80FC-3F77082AE50F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64543682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CE4F64-7B8F-42E4-8E79-3F55635B8874}" type="datetimeFigureOut">
              <a:rPr lang="en-IN" smtClean="0"/>
              <a:t>30-07-2023</a:t>
            </a:fld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B54710-83D2-4A79-80FC-3F77082AE50F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54849812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CE4F64-7B8F-42E4-8E79-3F55635B8874}" type="datetimeFigureOut">
              <a:rPr lang="en-IN" smtClean="0"/>
              <a:t>30-07-2023</a:t>
            </a:fld>
            <a:endParaRPr lang="en-IN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B54710-83D2-4A79-80FC-3F77082AE50F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41485011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CE4F64-7B8F-42E4-8E79-3F55635B8874}" type="datetimeFigureOut">
              <a:rPr lang="en-IN" smtClean="0"/>
              <a:t>30-07-2023</a:t>
            </a:fld>
            <a:endParaRPr lang="en-IN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B54710-83D2-4A79-80FC-3F77082AE50F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79055681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CE4F64-7B8F-42E4-8E79-3F55635B8874}" type="datetimeFigureOut">
              <a:rPr lang="en-IN" smtClean="0"/>
              <a:t>30-07-2023</a:t>
            </a:fld>
            <a:endParaRPr lang="en-IN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B54710-83D2-4A79-80FC-3F77082AE50F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53229132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CE4F64-7B8F-42E4-8E79-3F55635B8874}" type="datetimeFigureOut">
              <a:rPr lang="en-IN" smtClean="0"/>
              <a:t>30-07-2023</a:t>
            </a:fld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B54710-83D2-4A79-80FC-3F77082AE50F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75699330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CE4F64-7B8F-42E4-8E79-3F55635B8874}" type="datetimeFigureOut">
              <a:rPr lang="en-IN" smtClean="0"/>
              <a:t>30-07-2023</a:t>
            </a:fld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B54710-83D2-4A79-80FC-3F77082AE50F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01475258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4CE4F64-7B8F-42E4-8E79-3F55635B8874}" type="datetimeFigureOut">
              <a:rPr lang="en-IN" smtClean="0"/>
              <a:t>30-07-2023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1B54710-83D2-4A79-80FC-3F77082AE50F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11999330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Table 1">
            <a:extLst>
              <a:ext uri="{FF2B5EF4-FFF2-40B4-BE49-F238E27FC236}">
                <a16:creationId xmlns:a16="http://schemas.microsoft.com/office/drawing/2014/main" id="{C69E09F0-6CE7-229A-F0A7-9790FED4612A}"/>
              </a:ext>
            </a:extLst>
          </p:cNvPr>
          <p:cNvGraphicFramePr>
            <a:graphicFrameLocks noGrp="1"/>
          </p:cNvGraphicFramePr>
          <p:nvPr/>
        </p:nvGraphicFramePr>
        <p:xfrm>
          <a:off x="814705" y="1761331"/>
          <a:ext cx="5228590" cy="4408805"/>
        </p:xfrm>
        <a:graphic>
          <a:graphicData uri="http://schemas.openxmlformats.org/drawingml/2006/table">
            <a:tbl>
              <a:tblPr firstRow="1" bandRow="1">
                <a:tableStyleId>{1FECB4D8-DB02-4DC6-A0A2-4F2EBAE1DC90}</a:tableStyleId>
              </a:tblPr>
              <a:tblGrid>
                <a:gridCol w="701376">
                  <a:extLst>
                    <a:ext uri="{9D8B030D-6E8A-4147-A177-3AD203B41FA5}">
                      <a16:colId xmlns:a16="http://schemas.microsoft.com/office/drawing/2014/main" val="3007653977"/>
                    </a:ext>
                  </a:extLst>
                </a:gridCol>
                <a:gridCol w="3377652">
                  <a:extLst>
                    <a:ext uri="{9D8B030D-6E8A-4147-A177-3AD203B41FA5}">
                      <a16:colId xmlns:a16="http://schemas.microsoft.com/office/drawing/2014/main" val="691417179"/>
                    </a:ext>
                  </a:extLst>
                </a:gridCol>
                <a:gridCol w="1149562">
                  <a:extLst>
                    <a:ext uri="{9D8B030D-6E8A-4147-A177-3AD203B41FA5}">
                      <a16:colId xmlns:a16="http://schemas.microsoft.com/office/drawing/2014/main" val="99035535"/>
                    </a:ext>
                  </a:extLst>
                </a:gridCol>
              </a:tblGrid>
              <a:tr h="331470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IN" sz="1400" b="1" kern="100">
                          <a:solidFill>
                            <a:schemeClr val="bg1"/>
                          </a:solidFill>
                          <a:effectLst/>
                          <a:latin typeface="+mn-lt"/>
                        </a:rPr>
                        <a:t>S. No.</a:t>
                      </a:r>
                      <a:endParaRPr lang="en-IN" sz="1200" kern="100">
                        <a:solidFill>
                          <a:schemeClr val="bg1"/>
                        </a:solidFill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IN" sz="1400" b="1" kern="100">
                          <a:solidFill>
                            <a:schemeClr val="bg1"/>
                          </a:solidFill>
                          <a:effectLst/>
                          <a:latin typeface="+mn-lt"/>
                        </a:rPr>
                        <a:t> Gene name</a:t>
                      </a:r>
                      <a:endParaRPr lang="en-IN" sz="1200" kern="100">
                        <a:solidFill>
                          <a:schemeClr val="bg1"/>
                        </a:solidFill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IN" sz="1400" b="1" kern="100" dirty="0">
                          <a:solidFill>
                            <a:schemeClr val="bg1"/>
                          </a:solidFill>
                          <a:effectLst/>
                          <a:latin typeface="+mn-lt"/>
                        </a:rPr>
                        <a:t>Gene symbol</a:t>
                      </a:r>
                      <a:endParaRPr lang="en-IN" sz="1200" kern="100" dirty="0">
                        <a:solidFill>
                          <a:schemeClr val="bg1"/>
                        </a:solidFill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2263867371"/>
                  </a:ext>
                </a:extLst>
              </a:tr>
              <a:tr h="331470"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200" b="1" kern="100">
                          <a:solidFill>
                            <a:schemeClr val="tx1"/>
                          </a:solidFill>
                          <a:effectLst/>
                        </a:rPr>
                        <a:t>1</a:t>
                      </a:r>
                      <a:endParaRPr lang="en-IN" sz="1100" kern="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IN" sz="1200" kern="100">
                          <a:solidFill>
                            <a:schemeClr val="tx1"/>
                          </a:solidFill>
                          <a:effectLst/>
                        </a:rPr>
                        <a:t> Protocadherin 1</a:t>
                      </a:r>
                      <a:endParaRPr lang="en-IN" sz="1100" kern="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IN" sz="1200" kern="100">
                          <a:solidFill>
                            <a:schemeClr val="tx1"/>
                          </a:solidFill>
                          <a:effectLst/>
                        </a:rPr>
                        <a:t>PCDH1</a:t>
                      </a:r>
                      <a:endParaRPr lang="en-IN" sz="1100" kern="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2598158675"/>
                  </a:ext>
                </a:extLst>
              </a:tr>
              <a:tr h="331470"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200" b="1" kern="100">
                          <a:solidFill>
                            <a:schemeClr val="tx1"/>
                          </a:solidFill>
                          <a:effectLst/>
                        </a:rPr>
                        <a:t>2</a:t>
                      </a:r>
                      <a:endParaRPr lang="en-IN" sz="1100" kern="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IN" sz="1200" kern="100">
                          <a:solidFill>
                            <a:schemeClr val="tx1"/>
                          </a:solidFill>
                          <a:effectLst/>
                        </a:rPr>
                        <a:t> Activin receptor type-1B</a:t>
                      </a:r>
                      <a:endParaRPr lang="en-IN" sz="1100" kern="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IN" sz="1200" kern="100">
                          <a:solidFill>
                            <a:schemeClr val="tx1"/>
                          </a:solidFill>
                          <a:effectLst/>
                        </a:rPr>
                        <a:t>ACVR1B</a:t>
                      </a:r>
                      <a:endParaRPr lang="en-IN" sz="1100" kern="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632449308"/>
                  </a:ext>
                </a:extLst>
              </a:tr>
              <a:tr h="331470"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200" b="1" kern="100">
                          <a:solidFill>
                            <a:schemeClr val="tx1"/>
                          </a:solidFill>
                          <a:effectLst/>
                        </a:rPr>
                        <a:t>3</a:t>
                      </a:r>
                      <a:endParaRPr lang="en-IN" sz="1100" kern="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IN" sz="1200" kern="100">
                          <a:solidFill>
                            <a:schemeClr val="tx1"/>
                          </a:solidFill>
                          <a:effectLst/>
                        </a:rPr>
                        <a:t> Beta-arrestin-1</a:t>
                      </a:r>
                      <a:endParaRPr lang="en-IN" sz="1100" kern="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IN" sz="1200" kern="100">
                          <a:solidFill>
                            <a:schemeClr val="tx1"/>
                          </a:solidFill>
                          <a:effectLst/>
                        </a:rPr>
                        <a:t>ARRB1</a:t>
                      </a:r>
                      <a:endParaRPr lang="en-IN" sz="1100" kern="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2746822734"/>
                  </a:ext>
                </a:extLst>
              </a:tr>
              <a:tr h="331470"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200" b="1" kern="100">
                          <a:solidFill>
                            <a:schemeClr val="tx1"/>
                          </a:solidFill>
                          <a:effectLst/>
                        </a:rPr>
                        <a:t>4</a:t>
                      </a:r>
                      <a:endParaRPr lang="en-IN" sz="1100" kern="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IN" sz="1200" kern="100">
                          <a:solidFill>
                            <a:schemeClr val="tx1"/>
                          </a:solidFill>
                          <a:effectLst/>
                        </a:rPr>
                        <a:t> Histone acetyltransferase p300</a:t>
                      </a:r>
                      <a:endParaRPr lang="en-IN" sz="1100" kern="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IN" sz="1200" kern="100">
                          <a:solidFill>
                            <a:schemeClr val="tx1"/>
                          </a:solidFill>
                          <a:effectLst/>
                        </a:rPr>
                        <a:t>EP300</a:t>
                      </a:r>
                      <a:endParaRPr lang="en-IN" sz="1100" kern="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331187350"/>
                  </a:ext>
                </a:extLst>
              </a:tr>
              <a:tr h="331470"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200" b="1" kern="100">
                          <a:solidFill>
                            <a:schemeClr val="tx1"/>
                          </a:solidFill>
                          <a:effectLst/>
                        </a:rPr>
                        <a:t>5</a:t>
                      </a:r>
                      <a:endParaRPr lang="en-IN" sz="1100" kern="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IN" sz="1200" kern="100">
                          <a:solidFill>
                            <a:schemeClr val="tx1"/>
                          </a:solidFill>
                          <a:effectLst/>
                        </a:rPr>
                        <a:t> Protein Wnt-5a</a:t>
                      </a:r>
                      <a:endParaRPr lang="en-IN" sz="1100" kern="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IN" sz="1200" kern="100">
                          <a:solidFill>
                            <a:schemeClr val="tx1"/>
                          </a:solidFill>
                          <a:effectLst/>
                        </a:rPr>
                        <a:t>WNT5A</a:t>
                      </a:r>
                      <a:endParaRPr lang="en-IN" sz="1100" kern="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3769752775"/>
                  </a:ext>
                </a:extLst>
              </a:tr>
              <a:tr h="331470"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200" b="1" kern="100">
                          <a:solidFill>
                            <a:schemeClr val="tx1"/>
                          </a:solidFill>
                          <a:effectLst/>
                        </a:rPr>
                        <a:t>6</a:t>
                      </a:r>
                      <a:endParaRPr lang="en-IN" sz="1100" kern="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IN" sz="1200" kern="100">
                          <a:solidFill>
                            <a:schemeClr val="tx1"/>
                          </a:solidFill>
                          <a:effectLst/>
                        </a:rPr>
                        <a:t> TGF-beta receptor type-1</a:t>
                      </a:r>
                      <a:endParaRPr lang="en-IN" sz="1100" kern="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IN" sz="1200" kern="100">
                          <a:solidFill>
                            <a:schemeClr val="tx1"/>
                          </a:solidFill>
                          <a:effectLst/>
                        </a:rPr>
                        <a:t>TGFBR1</a:t>
                      </a:r>
                      <a:endParaRPr lang="en-IN" sz="1100" kern="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4110284068"/>
                  </a:ext>
                </a:extLst>
              </a:tr>
              <a:tr h="331470"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200" b="1" kern="100">
                          <a:solidFill>
                            <a:schemeClr val="tx1"/>
                          </a:solidFill>
                          <a:effectLst/>
                        </a:rPr>
                        <a:t>7</a:t>
                      </a:r>
                      <a:endParaRPr lang="en-IN" sz="1100" kern="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IN" sz="1200" kern="100">
                          <a:solidFill>
                            <a:schemeClr val="tx1"/>
                          </a:solidFill>
                          <a:effectLst/>
                        </a:rPr>
                        <a:t> Follistatin-related protein 1</a:t>
                      </a:r>
                      <a:endParaRPr lang="en-IN" sz="1100" kern="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IN" sz="1200" kern="100">
                          <a:solidFill>
                            <a:schemeClr val="tx1"/>
                          </a:solidFill>
                          <a:effectLst/>
                        </a:rPr>
                        <a:t>FSTL1</a:t>
                      </a:r>
                      <a:endParaRPr lang="en-IN" sz="1100" kern="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732973854"/>
                  </a:ext>
                </a:extLst>
              </a:tr>
              <a:tr h="331470"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200" b="1" kern="100">
                          <a:solidFill>
                            <a:schemeClr val="tx1"/>
                          </a:solidFill>
                          <a:effectLst/>
                        </a:rPr>
                        <a:t>8</a:t>
                      </a:r>
                      <a:endParaRPr lang="en-IN" sz="1100" kern="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IN" sz="1200" kern="100">
                          <a:solidFill>
                            <a:schemeClr val="tx1"/>
                          </a:solidFill>
                          <a:effectLst/>
                        </a:rPr>
                        <a:t> Snf2-related CREBBP activator protein</a:t>
                      </a:r>
                      <a:endParaRPr lang="en-IN" sz="1100" kern="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IN" sz="1200" kern="100">
                          <a:solidFill>
                            <a:schemeClr val="tx1"/>
                          </a:solidFill>
                          <a:effectLst/>
                        </a:rPr>
                        <a:t>SRCAP</a:t>
                      </a:r>
                      <a:endParaRPr lang="en-IN" sz="1100" kern="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362328643"/>
                  </a:ext>
                </a:extLst>
              </a:tr>
              <a:tr h="331470"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200" b="1" kern="100">
                          <a:solidFill>
                            <a:schemeClr val="tx1"/>
                          </a:solidFill>
                          <a:effectLst/>
                        </a:rPr>
                        <a:t>9</a:t>
                      </a:r>
                      <a:endParaRPr lang="en-IN" sz="1100" kern="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IN" sz="1200" kern="100">
                          <a:solidFill>
                            <a:schemeClr val="tx1"/>
                          </a:solidFill>
                          <a:effectLst/>
                        </a:rPr>
                        <a:t> Casein kinase I isoform alpha</a:t>
                      </a:r>
                      <a:endParaRPr lang="en-IN" sz="1100" kern="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IN" sz="1200" kern="100">
                          <a:solidFill>
                            <a:schemeClr val="tx1"/>
                          </a:solidFill>
                          <a:effectLst/>
                        </a:rPr>
                        <a:t>CSNK1A1</a:t>
                      </a:r>
                      <a:endParaRPr lang="en-IN" sz="1100" kern="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3779775522"/>
                  </a:ext>
                </a:extLst>
              </a:tr>
              <a:tr h="396240"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200" b="1" kern="100">
                          <a:solidFill>
                            <a:schemeClr val="tx1"/>
                          </a:solidFill>
                          <a:effectLst/>
                        </a:rPr>
                        <a:t>1</a:t>
                      </a:r>
                      <a:r>
                        <a:rPr lang="en-IN" sz="1200" b="1" kern="100">
                          <a:solidFill>
                            <a:schemeClr val="tx1"/>
                          </a:solidFill>
                          <a:effectLst/>
                        </a:rPr>
                        <a:t>0</a:t>
                      </a:r>
                      <a:endParaRPr lang="en-IN" sz="1100" kern="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IN" sz="1200" kern="100">
                          <a:solidFill>
                            <a:schemeClr val="tx1"/>
                          </a:solidFill>
                          <a:effectLst/>
                        </a:rPr>
                        <a:t> Guanine nucleotide-binding protein subunit beta-4</a:t>
                      </a:r>
                      <a:endParaRPr lang="en-IN" sz="1100" kern="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IN" sz="1200" kern="100">
                          <a:solidFill>
                            <a:schemeClr val="tx1"/>
                          </a:solidFill>
                          <a:effectLst/>
                        </a:rPr>
                        <a:t>GNB4</a:t>
                      </a:r>
                      <a:endParaRPr lang="en-IN" sz="1100" kern="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58387665"/>
                  </a:ext>
                </a:extLst>
              </a:tr>
              <a:tr h="366395"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IN" sz="1200" b="1" kern="100">
                          <a:solidFill>
                            <a:schemeClr val="tx1"/>
                          </a:solidFill>
                          <a:effectLst/>
                        </a:rPr>
                        <a:t>11</a:t>
                      </a:r>
                      <a:endParaRPr lang="en-IN" sz="1100" kern="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200" kern="100">
                          <a:solidFill>
                            <a:schemeClr val="tx1"/>
                          </a:solidFill>
                          <a:effectLst/>
                        </a:rPr>
                        <a:t> Mothers against decapentaplegic homolog 4</a:t>
                      </a:r>
                      <a:endParaRPr lang="en-IN" sz="1100" kern="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IN" sz="1200" kern="100">
                          <a:solidFill>
                            <a:schemeClr val="tx1"/>
                          </a:solidFill>
                          <a:effectLst/>
                        </a:rPr>
                        <a:t>SMAD4</a:t>
                      </a:r>
                      <a:endParaRPr lang="en-IN" sz="1100" kern="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2085123343"/>
                  </a:ext>
                </a:extLst>
              </a:tr>
              <a:tr h="331470"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IN" sz="1200" b="1" kern="100">
                          <a:solidFill>
                            <a:schemeClr val="tx1"/>
                          </a:solidFill>
                          <a:effectLst/>
                        </a:rPr>
                        <a:t>12</a:t>
                      </a:r>
                      <a:endParaRPr lang="en-IN" sz="1100" kern="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IN" sz="1200" kern="100">
                          <a:solidFill>
                            <a:schemeClr val="tx1"/>
                          </a:solidFill>
                          <a:effectLst/>
                        </a:rPr>
                        <a:t> B-cell CLL/lymphoma 9 protein</a:t>
                      </a:r>
                      <a:endParaRPr lang="en-IN" sz="1100" kern="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IN" sz="1200" kern="100" dirty="0">
                          <a:solidFill>
                            <a:schemeClr val="tx1"/>
                          </a:solidFill>
                          <a:effectLst/>
                        </a:rPr>
                        <a:t>BCL9</a:t>
                      </a:r>
                      <a:endParaRPr lang="en-IN" sz="1100" kern="10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1902859730"/>
                  </a:ext>
                </a:extLst>
              </a:tr>
            </a:tbl>
          </a:graphicData>
        </a:graphic>
      </p:graphicFrame>
      <p:sp>
        <p:nvSpPr>
          <p:cNvPr id="4" name="TextBox 3">
            <a:extLst>
              <a:ext uri="{FF2B5EF4-FFF2-40B4-BE49-F238E27FC236}">
                <a16:creationId xmlns:a16="http://schemas.microsoft.com/office/drawing/2014/main" id="{488ED330-778F-397C-7019-3925169C82BA}"/>
              </a:ext>
            </a:extLst>
          </p:cNvPr>
          <p:cNvSpPr txBox="1"/>
          <p:nvPr/>
        </p:nvSpPr>
        <p:spPr>
          <a:xfrm>
            <a:off x="623147" y="1088873"/>
            <a:ext cx="4745567" cy="28027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en-US" sz="1200" b="1" kern="1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Table S2 List of shortlisted miR-22 targets</a:t>
            </a:r>
            <a:endParaRPr lang="en-IN" sz="1100" kern="1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63522678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 2013 - 2022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 2013 - 2022</Template>
  <TotalTime>0</TotalTime>
  <Words>95</Words>
  <Application>Microsoft Office PowerPoint</Application>
  <PresentationFormat>A4 Paper (210x297 mm)</PresentationFormat>
  <Paragraphs>40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PRIYA RANI</dc:creator>
  <cp:lastModifiedBy>PRIYA RANI</cp:lastModifiedBy>
  <cp:revision>1</cp:revision>
  <dcterms:created xsi:type="dcterms:W3CDTF">2023-07-30T01:16:17Z</dcterms:created>
  <dcterms:modified xsi:type="dcterms:W3CDTF">2023-07-30T01:16:47Z</dcterms:modified>
</cp:coreProperties>
</file>